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563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92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101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292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282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485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250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282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30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863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834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9A111-9F0F-4E76-A97C-0B4DE0159A7C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EC6C2-1B28-4A48-960E-B83EFC129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25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6755" y="311084"/>
            <a:ext cx="1145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A.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515528" y="606601"/>
            <a:ext cx="4526283" cy="1392931"/>
            <a:chOff x="-78109" y="478139"/>
            <a:chExt cx="4526283" cy="139293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619" r="14371" b="48596"/>
            <a:stretch/>
          </p:blipFill>
          <p:spPr>
            <a:xfrm>
              <a:off x="401781" y="1042395"/>
              <a:ext cx="4046393" cy="828675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2247860" y="1047187"/>
              <a:ext cx="1101853" cy="81909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267177" y="478139"/>
              <a:ext cx="144602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ELENOF</a:t>
              </a:r>
            </a:p>
            <a:p>
              <a:r>
                <a:rPr lang="en-US" b="1" dirty="0"/>
                <a:t>1     2     3 </a:t>
              </a:r>
            </a:p>
          </p:txBody>
        </p:sp>
        <p:cxnSp>
          <p:nvCxnSpPr>
            <p:cNvPr id="8" name="Straight Arrow Connector 7"/>
            <p:cNvCxnSpPr/>
            <p:nvPr/>
          </p:nvCxnSpPr>
          <p:spPr>
            <a:xfrm>
              <a:off x="520609" y="1258244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-59889" y="1088967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kD</a:t>
              </a:r>
            </a:p>
          </p:txBody>
        </p:sp>
        <p:cxnSp>
          <p:nvCxnSpPr>
            <p:cNvPr id="10" name="Straight Arrow Connector 9"/>
            <p:cNvCxnSpPr/>
            <p:nvPr/>
          </p:nvCxnSpPr>
          <p:spPr>
            <a:xfrm>
              <a:off x="494731" y="1617154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-78109" y="1447877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kD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6210300" y="564360"/>
            <a:ext cx="97283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US" b="1" dirty="0"/>
              <a:t>WT</a:t>
            </a:r>
          </a:p>
          <a:p>
            <a:pPr marL="342900" indent="-342900">
              <a:buAutoNum type="arabicPeriod"/>
            </a:pPr>
            <a:r>
              <a:rPr lang="en-US" b="1" dirty="0"/>
              <a:t>KO 1</a:t>
            </a:r>
          </a:p>
          <a:p>
            <a:pPr marL="342900" indent="-342900">
              <a:buAutoNum type="arabicPeriod"/>
            </a:pPr>
            <a:r>
              <a:rPr lang="en-US" b="1" dirty="0"/>
              <a:t>KO 2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5" t="-2578" r="33648" b="13520"/>
          <a:stretch/>
        </p:blipFill>
        <p:spPr>
          <a:xfrm>
            <a:off x="1762125" y="3009900"/>
            <a:ext cx="2228964" cy="33638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2879864" y="2342515"/>
            <a:ext cx="14460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ctin</a:t>
            </a:r>
          </a:p>
          <a:p>
            <a:r>
              <a:rPr lang="en-US" b="1" dirty="0"/>
              <a:t>1     2     3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2889122" y="2922284"/>
            <a:ext cx="1101853" cy="81909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767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546755" y="311084"/>
            <a:ext cx="1134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B.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515528" y="631809"/>
            <a:ext cx="4854780" cy="1381806"/>
            <a:chOff x="-78109" y="503347"/>
            <a:chExt cx="4854780" cy="1381806"/>
          </a:xfrm>
        </p:grpSpPr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619" r="14371" b="48596"/>
            <a:stretch/>
          </p:blipFill>
          <p:spPr>
            <a:xfrm>
              <a:off x="401781" y="1042395"/>
              <a:ext cx="4046393" cy="828675"/>
            </a:xfrm>
            <a:prstGeom prst="rect">
              <a:avLst/>
            </a:prstGeom>
          </p:spPr>
        </p:pic>
        <p:sp>
          <p:nvSpPr>
            <p:cNvPr id="38" name="Rectangle 37"/>
            <p:cNvSpPr/>
            <p:nvPr/>
          </p:nvSpPr>
          <p:spPr>
            <a:xfrm>
              <a:off x="3273495" y="1066063"/>
              <a:ext cx="1109815" cy="819090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330645" y="503347"/>
              <a:ext cx="144602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ELENOF</a:t>
              </a:r>
            </a:p>
            <a:p>
              <a:r>
                <a:rPr lang="en-US" b="1" dirty="0"/>
                <a:t>1     2     3 </a:t>
              </a:r>
            </a:p>
          </p:txBody>
        </p:sp>
        <p:cxnSp>
          <p:nvCxnSpPr>
            <p:cNvPr id="3" name="Straight Arrow Connector 2"/>
            <p:cNvCxnSpPr/>
            <p:nvPr/>
          </p:nvCxnSpPr>
          <p:spPr>
            <a:xfrm>
              <a:off x="520609" y="1258244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-59889" y="1088967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kD</a:t>
              </a:r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>
              <a:off x="494731" y="1617154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-78109" y="1447877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kD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395606" y="2466316"/>
            <a:ext cx="4679721" cy="1792035"/>
            <a:chOff x="-231547" y="1908282"/>
            <a:chExt cx="4679721" cy="179203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576" r="14821" b="35183"/>
            <a:stretch/>
          </p:blipFill>
          <p:spPr>
            <a:xfrm>
              <a:off x="354028" y="2484259"/>
              <a:ext cx="4094146" cy="1216058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3139457" y="2516590"/>
              <a:ext cx="927718" cy="867266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182298" y="1908282"/>
              <a:ext cx="90601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/>
                <a:t>p21</a:t>
              </a:r>
            </a:p>
            <a:p>
              <a:pPr algn="ctr"/>
              <a:r>
                <a:rPr lang="en-US" b="1" dirty="0"/>
                <a:t>1   2   3 </a:t>
              </a:r>
            </a:p>
          </p:txBody>
        </p:sp>
        <p:cxnSp>
          <p:nvCxnSpPr>
            <p:cNvPr id="34" name="Straight Arrow Connector 33"/>
            <p:cNvCxnSpPr/>
            <p:nvPr/>
          </p:nvCxnSpPr>
          <p:spPr>
            <a:xfrm>
              <a:off x="400707" y="2960902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-231547" y="2791625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kD</a:t>
              </a:r>
            </a:p>
          </p:txBody>
        </p:sp>
        <p:cxnSp>
          <p:nvCxnSpPr>
            <p:cNvPr id="36" name="Straight Arrow Connector 35"/>
            <p:cNvCxnSpPr/>
            <p:nvPr/>
          </p:nvCxnSpPr>
          <p:spPr>
            <a:xfrm>
              <a:off x="400707" y="3307836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-231547" y="3163294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kD</a:t>
              </a:r>
            </a:p>
          </p:txBody>
        </p:sp>
      </p:grpSp>
      <p:cxnSp>
        <p:nvCxnSpPr>
          <p:cNvPr id="53" name="Straight Arrow Connector 52"/>
          <p:cNvCxnSpPr/>
          <p:nvPr/>
        </p:nvCxnSpPr>
        <p:spPr>
          <a:xfrm>
            <a:off x="1033461" y="3160939"/>
            <a:ext cx="338401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401207" y="2991662"/>
            <a:ext cx="6322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35kD</a:t>
            </a: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08" r="35515" b="82239"/>
          <a:stretch/>
        </p:blipFill>
        <p:spPr>
          <a:xfrm flipV="1">
            <a:off x="1488105" y="5041186"/>
            <a:ext cx="3474521" cy="1196380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3642216" y="5480659"/>
            <a:ext cx="1077643" cy="50895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/>
          </a:p>
        </p:txBody>
      </p:sp>
      <p:cxnSp>
        <p:nvCxnSpPr>
          <p:cNvPr id="50" name="Straight Arrow Connector 49"/>
          <p:cNvCxnSpPr/>
          <p:nvPr/>
        </p:nvCxnSpPr>
        <p:spPr>
          <a:xfrm flipH="1">
            <a:off x="4962626" y="5649936"/>
            <a:ext cx="651048" cy="1165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613674" y="5492312"/>
            <a:ext cx="6322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55kD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210300" y="564360"/>
            <a:ext cx="97283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US" b="1" dirty="0"/>
              <a:t>WT</a:t>
            </a:r>
          </a:p>
          <a:p>
            <a:pPr marL="342900" indent="-342900">
              <a:buAutoNum type="arabicPeriod"/>
            </a:pPr>
            <a:r>
              <a:rPr lang="en-US" b="1" dirty="0"/>
              <a:t>KO 1</a:t>
            </a:r>
          </a:p>
          <a:p>
            <a:pPr marL="342900" indent="-342900">
              <a:buAutoNum type="arabicPeriod"/>
            </a:pPr>
            <a:r>
              <a:rPr lang="en-US" b="1" dirty="0"/>
              <a:t>KO 2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708044" y="4834328"/>
            <a:ext cx="10118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Actin</a:t>
            </a:r>
          </a:p>
          <a:p>
            <a:pPr algn="ctr"/>
            <a:r>
              <a:rPr lang="en-US" b="1" dirty="0"/>
              <a:t>1    2    3 </a:t>
            </a:r>
          </a:p>
        </p:txBody>
      </p:sp>
    </p:spTree>
    <p:extLst>
      <p:ext uri="{BB962C8B-B14F-4D97-AF65-F5344CB8AC3E}">
        <p14:creationId xmlns:p14="http://schemas.microsoft.com/office/powerpoint/2010/main" val="16728664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/>
          <p:cNvGrpSpPr/>
          <p:nvPr/>
        </p:nvGrpSpPr>
        <p:grpSpPr>
          <a:xfrm>
            <a:off x="0" y="653558"/>
            <a:ext cx="3768436" cy="1421951"/>
            <a:chOff x="-158461" y="753389"/>
            <a:chExt cx="3768436" cy="1421951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619" r="14371" b="48596"/>
            <a:stretch/>
          </p:blipFill>
          <p:spPr>
            <a:xfrm>
              <a:off x="527595" y="1346665"/>
              <a:ext cx="3082380" cy="828675"/>
            </a:xfrm>
            <a:prstGeom prst="rect">
              <a:avLst/>
            </a:prstGeom>
          </p:spPr>
        </p:pic>
        <p:sp>
          <p:nvSpPr>
            <p:cNvPr id="21" name="Rectangle 20"/>
            <p:cNvSpPr/>
            <p:nvPr/>
          </p:nvSpPr>
          <p:spPr>
            <a:xfrm>
              <a:off x="1249173" y="1308265"/>
              <a:ext cx="506118" cy="805283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063713" y="753389"/>
              <a:ext cx="115561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SELENOF</a:t>
              </a:r>
            </a:p>
            <a:p>
              <a:r>
                <a:rPr lang="en-US" b="1" dirty="0"/>
                <a:t>   1    2 </a:t>
              </a:r>
            </a:p>
          </p:txBody>
        </p:sp>
        <p:cxnSp>
          <p:nvCxnSpPr>
            <p:cNvPr id="30" name="Straight Arrow Connector 29"/>
            <p:cNvCxnSpPr/>
            <p:nvPr/>
          </p:nvCxnSpPr>
          <p:spPr>
            <a:xfrm>
              <a:off x="440257" y="1579211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-140241" y="1409934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kD</a:t>
              </a:r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>
              <a:off x="414379" y="1938121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-158461" y="1768844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kD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59446" y="2084059"/>
            <a:ext cx="3703779" cy="1841071"/>
            <a:chOff x="-176681" y="2484605"/>
            <a:chExt cx="3703779" cy="1841071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576" r="14821" b="35183"/>
            <a:stretch/>
          </p:blipFill>
          <p:spPr>
            <a:xfrm>
              <a:off x="460920" y="3109618"/>
              <a:ext cx="3066178" cy="1216058"/>
            </a:xfrm>
            <a:prstGeom prst="rect">
              <a:avLst/>
            </a:prstGeom>
          </p:spPr>
        </p:pic>
        <p:sp>
          <p:nvSpPr>
            <p:cNvPr id="17" name="Rectangle 16"/>
            <p:cNvSpPr/>
            <p:nvPr/>
          </p:nvSpPr>
          <p:spPr>
            <a:xfrm>
              <a:off x="1291983" y="3052708"/>
              <a:ext cx="463308" cy="867266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163449" y="2484605"/>
              <a:ext cx="68320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/>
                <a:t>p21</a:t>
              </a:r>
            </a:p>
            <a:p>
              <a:pPr algn="ctr"/>
              <a:r>
                <a:rPr lang="en-US" b="1" dirty="0"/>
                <a:t> 1   2 </a:t>
              </a:r>
            </a:p>
          </p:txBody>
        </p:sp>
        <p:cxnSp>
          <p:nvCxnSpPr>
            <p:cNvPr id="34" name="Straight Arrow Connector 33"/>
            <p:cNvCxnSpPr/>
            <p:nvPr/>
          </p:nvCxnSpPr>
          <p:spPr>
            <a:xfrm>
              <a:off x="422037" y="3574273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-158461" y="3404996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kD</a:t>
              </a:r>
            </a:p>
          </p:txBody>
        </p:sp>
        <p:cxnSp>
          <p:nvCxnSpPr>
            <p:cNvPr id="36" name="Straight Arrow Connector 35"/>
            <p:cNvCxnSpPr/>
            <p:nvPr/>
          </p:nvCxnSpPr>
          <p:spPr>
            <a:xfrm>
              <a:off x="396159" y="3933183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-176681" y="3763906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kD</a:t>
              </a:r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>
              <a:off x="427031" y="3230058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-119931" y="3060781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5kD</a:t>
              </a:r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163133" y="4030239"/>
            <a:ext cx="4128226" cy="1218383"/>
            <a:chOff x="3672194" y="3145799"/>
            <a:chExt cx="4128226" cy="1218383"/>
          </a:xfrm>
        </p:grpSpPr>
        <p:sp>
          <p:nvSpPr>
            <p:cNvPr id="27" name="TextBox 26"/>
            <p:cNvSpPr txBox="1"/>
            <p:nvPr/>
          </p:nvSpPr>
          <p:spPr>
            <a:xfrm>
              <a:off x="4892181" y="3145799"/>
              <a:ext cx="68320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/>
                <a:t>p27</a:t>
              </a:r>
            </a:p>
            <a:p>
              <a:pPr algn="ctr"/>
              <a:r>
                <a:rPr lang="en-US" b="1" dirty="0"/>
                <a:t>1    2 </a:t>
              </a:r>
            </a:p>
          </p:txBody>
        </p:sp>
        <p:grpSp>
          <p:nvGrpSpPr>
            <p:cNvPr id="74" name="Group 73"/>
            <p:cNvGrpSpPr/>
            <p:nvPr/>
          </p:nvGrpSpPr>
          <p:grpSpPr>
            <a:xfrm>
              <a:off x="3672194" y="3717647"/>
              <a:ext cx="4128226" cy="646535"/>
              <a:chOff x="3672194" y="3717647"/>
              <a:chExt cx="4128226" cy="646535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7542"/>
              <a:stretch/>
            </p:blipFill>
            <p:spPr>
              <a:xfrm>
                <a:off x="4200732" y="3717647"/>
                <a:ext cx="3599688" cy="646535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4945434" y="3717647"/>
                <a:ext cx="532257" cy="409972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txBody>
              <a:bodyPr wrap="square" rtlCol="0">
                <a:spAutoFit/>
              </a:bodyPr>
              <a:lstStyle/>
              <a:p>
                <a:endParaRPr lang="en-US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44" name="Straight Arrow Connector 43"/>
              <p:cNvCxnSpPr/>
              <p:nvPr/>
            </p:nvCxnSpPr>
            <p:spPr>
              <a:xfrm>
                <a:off x="4435578" y="3933183"/>
                <a:ext cx="338401" cy="0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>
                <a:off x="3672194" y="3763906"/>
                <a:ext cx="63225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25kD</a:t>
                </a:r>
              </a:p>
            </p:txBody>
          </p:sp>
        </p:grpSp>
      </p:grpSp>
      <p:grpSp>
        <p:nvGrpSpPr>
          <p:cNvPr id="73" name="Group 72"/>
          <p:cNvGrpSpPr/>
          <p:nvPr/>
        </p:nvGrpSpPr>
        <p:grpSpPr>
          <a:xfrm>
            <a:off x="645085" y="5506130"/>
            <a:ext cx="2543467" cy="1148260"/>
            <a:chOff x="9167255" y="3679104"/>
            <a:chExt cx="1641676" cy="887577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08" r="35276" b="79649"/>
            <a:stretch/>
          </p:blipFill>
          <p:spPr>
            <a:xfrm flipV="1">
              <a:off x="9167255" y="3921541"/>
              <a:ext cx="1641676" cy="645140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9880597" y="4150054"/>
              <a:ext cx="336883" cy="369332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9822777" y="3679104"/>
              <a:ext cx="438901" cy="4995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ctin</a:t>
              </a:r>
            </a:p>
            <a:p>
              <a:r>
                <a:rPr lang="en-US" b="1" dirty="0"/>
                <a:t> 1   2</a:t>
              </a:r>
            </a:p>
          </p:txBody>
        </p:sp>
      </p:grpSp>
      <p:sp>
        <p:nvSpPr>
          <p:cNvPr id="76" name="TextBox 75"/>
          <p:cNvSpPr txBox="1"/>
          <p:nvPr/>
        </p:nvSpPr>
        <p:spPr>
          <a:xfrm>
            <a:off x="3626033" y="6152462"/>
            <a:ext cx="10412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55kD</a:t>
            </a:r>
          </a:p>
        </p:txBody>
      </p:sp>
      <p:cxnSp>
        <p:nvCxnSpPr>
          <p:cNvPr id="65" name="Straight Arrow Connector 64"/>
          <p:cNvCxnSpPr/>
          <p:nvPr/>
        </p:nvCxnSpPr>
        <p:spPr>
          <a:xfrm flipH="1">
            <a:off x="3188552" y="6310321"/>
            <a:ext cx="416907" cy="1141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546755" y="311084"/>
            <a:ext cx="1116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E.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610100" y="680416"/>
            <a:ext cx="10168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US" b="1" dirty="0"/>
              <a:t>-Dox</a:t>
            </a:r>
          </a:p>
          <a:p>
            <a:pPr marL="342900" indent="-342900">
              <a:buAutoNum type="arabicPeriod"/>
            </a:pPr>
            <a:r>
              <a:rPr lang="en-US" b="1" dirty="0"/>
              <a:t>+Dox</a:t>
            </a:r>
          </a:p>
        </p:txBody>
      </p:sp>
    </p:spTree>
    <p:extLst>
      <p:ext uri="{BB962C8B-B14F-4D97-AF65-F5344CB8AC3E}">
        <p14:creationId xmlns:p14="http://schemas.microsoft.com/office/powerpoint/2010/main" val="38246076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354232" y="184299"/>
            <a:ext cx="1604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6C.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5436" y="668090"/>
            <a:ext cx="3912558" cy="1623246"/>
            <a:chOff x="5436" y="668090"/>
            <a:chExt cx="3912558" cy="1623246"/>
          </a:xfrm>
        </p:grpSpPr>
        <p:sp>
          <p:nvSpPr>
            <p:cNvPr id="10" name="TextBox 9"/>
            <p:cNvSpPr txBox="1"/>
            <p:nvPr/>
          </p:nvSpPr>
          <p:spPr>
            <a:xfrm>
              <a:off x="2798397" y="668090"/>
              <a:ext cx="1072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SELENOF 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4007" y="964893"/>
              <a:ext cx="3363987" cy="1326443"/>
            </a:xfrm>
            <a:prstGeom prst="rect">
              <a:avLst/>
            </a:prstGeom>
          </p:spPr>
        </p:pic>
        <p:sp>
          <p:nvSpPr>
            <p:cNvPr id="12" name="Rectangle 11"/>
            <p:cNvSpPr/>
            <p:nvPr/>
          </p:nvSpPr>
          <p:spPr>
            <a:xfrm>
              <a:off x="2521759" y="1308160"/>
              <a:ext cx="983105" cy="822017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>
              <a:off x="604154" y="1630967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23656" y="1444438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kD</a:t>
              </a:r>
            </a:p>
          </p:txBody>
        </p:sp>
        <p:cxnSp>
          <p:nvCxnSpPr>
            <p:cNvPr id="33" name="Straight Arrow Connector 32"/>
            <p:cNvCxnSpPr/>
            <p:nvPr/>
          </p:nvCxnSpPr>
          <p:spPr>
            <a:xfrm>
              <a:off x="578276" y="1938121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5436" y="1768844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0kD</a:t>
              </a:r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>
              <a:off x="601172" y="1323803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28332" y="1154526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5kD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-74110" y="2643274"/>
            <a:ext cx="3744042" cy="1368573"/>
            <a:chOff x="-74110" y="2643274"/>
            <a:chExt cx="3744042" cy="136857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514" r="13318" b="36775"/>
            <a:stretch/>
          </p:blipFill>
          <p:spPr>
            <a:xfrm>
              <a:off x="549638" y="3012606"/>
              <a:ext cx="3120294" cy="999241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568367" y="2643274"/>
              <a:ext cx="5732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LC3 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2396434" y="3012606"/>
              <a:ext cx="917165" cy="999241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9" name="Straight Arrow Connector 38"/>
            <p:cNvCxnSpPr/>
            <p:nvPr/>
          </p:nvCxnSpPr>
          <p:spPr>
            <a:xfrm>
              <a:off x="506388" y="3362002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-74110" y="3175473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15kD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69487" y="4398164"/>
            <a:ext cx="3406735" cy="1435155"/>
            <a:chOff x="140584" y="5264651"/>
            <a:chExt cx="3406735" cy="1435155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67" t="66843" r="20582" b="4013"/>
            <a:stretch/>
          </p:blipFill>
          <p:spPr>
            <a:xfrm>
              <a:off x="672250" y="5719418"/>
              <a:ext cx="2875069" cy="980388"/>
            </a:xfrm>
            <a:prstGeom prst="rect">
              <a:avLst/>
            </a:prstGeom>
          </p:spPr>
        </p:pic>
        <p:sp>
          <p:nvSpPr>
            <p:cNvPr id="14" name="Rectangle 13"/>
            <p:cNvSpPr/>
            <p:nvPr/>
          </p:nvSpPr>
          <p:spPr>
            <a:xfrm>
              <a:off x="1519764" y="5633983"/>
              <a:ext cx="1453902" cy="962128"/>
            </a:xfrm>
            <a:prstGeom prst="rect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16773" y="5264651"/>
              <a:ext cx="7328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ctin </a:t>
              </a:r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>
              <a:off x="799684" y="6234581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141552" y="6039426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35kD</a:t>
              </a:r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>
              <a:off x="808310" y="6429597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140584" y="6260320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5kD</a:t>
              </a:r>
            </a:p>
          </p:txBody>
        </p:sp>
        <p:cxnSp>
          <p:nvCxnSpPr>
            <p:cNvPr id="45" name="Straight Arrow Connector 44"/>
            <p:cNvCxnSpPr/>
            <p:nvPr/>
          </p:nvCxnSpPr>
          <p:spPr>
            <a:xfrm>
              <a:off x="796702" y="5927417"/>
              <a:ext cx="338401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154854" y="5758140"/>
              <a:ext cx="6322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55k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2028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9</TotalTime>
  <Words>86</Words>
  <Application>Microsoft Office PowerPoint</Application>
  <PresentationFormat>Widescreen</PresentationFormat>
  <Paragraphs>5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Loyola University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strati, Irida</dc:creator>
  <cp:lastModifiedBy>MDPI</cp:lastModifiedBy>
  <cp:revision>38</cp:revision>
  <dcterms:created xsi:type="dcterms:W3CDTF">2023-05-24T20:11:24Z</dcterms:created>
  <dcterms:modified xsi:type="dcterms:W3CDTF">2023-07-06T00:31:08Z</dcterms:modified>
</cp:coreProperties>
</file>